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03C54-4778-4914-8595-2FA25B6F41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630B1-794A-4CB2-847A-C2E3C34ACB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BF280-40B7-4EC0-998E-7B51105836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5804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076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5804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E6A91-4C03-424F-AEDD-E9ED9006DC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BDA3C-FC03-491B-8A3B-49879C49C8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43E50-2683-4DEE-AD20-6E4422587F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E70F2-04C3-42B8-8ED4-7FB2A2943A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4CEAE-99F4-4398-BB77-B5F133E51A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0760" y="365040"/>
            <a:ext cx="8543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D88C9-B355-4DE0-AD35-8F0CA40DF7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8646E-511F-414C-BBDF-D1D0135B93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ABEE1-E3CE-434D-B812-22B438577F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C4EFE-494A-4F3C-A1FE-EA3296A8B7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076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81040" y="6356520"/>
            <a:ext cx="3343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99588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CE96F3-2E6C-4DBB-972F-1077EC03B46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5"/>
          <p:cNvSpPr/>
          <p:nvPr/>
        </p:nvSpPr>
        <p:spPr>
          <a:xfrm>
            <a:off x="1733400" y="1353960"/>
            <a:ext cx="659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Supplemental Figure 1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Kaplan-Meier overall survival curve according to HMA therapeutic lin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Image 3" descr=""/>
          <p:cNvPicPr/>
          <p:nvPr/>
        </p:nvPicPr>
        <p:blipFill>
          <a:blip r:embed="rId1"/>
          <a:stretch/>
        </p:blipFill>
        <p:spPr>
          <a:xfrm>
            <a:off x="2041560" y="1825560"/>
            <a:ext cx="5699160" cy="32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3-16T09:53:52Z</dcterms:created>
  <dc:creator>Ludovic Gabellier</dc:creator>
  <dc:description/>
  <dc:language>en-US</dc:language>
  <cp:lastModifiedBy>Ludovic Gabellier</cp:lastModifiedBy>
  <dcterms:modified xsi:type="dcterms:W3CDTF">2023-03-16T10:01:45Z</dcterms:modified>
  <cp:revision>2</cp:revision>
  <dc:subject/>
  <dc:title>Présentation PowerPoint</dc:title>
</cp:coreProperties>
</file>